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92" d="100"/>
          <a:sy n="92" d="100"/>
        </p:scale>
        <p:origin x="69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42542D-7C69-4C1B-AD4B-2781E1362EDB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921AD9-7B80-4ADA-B320-1DA05726B9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08549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Fig S3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6DB3FFA-3AD9-4FEB-8A03-5A612FF74AD4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74454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09134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51324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57840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78827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13780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2961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85473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4082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49748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40016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24281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687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w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E08D6C-0B0B-4587-9786-8A5803620C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56556" y="106452"/>
            <a:ext cx="10915996" cy="1325563"/>
          </a:xfrm>
        </p:spPr>
        <p:txBody>
          <a:bodyPr>
            <a:normAutofit/>
          </a:bodyPr>
          <a:lstStyle/>
          <a:p>
            <a:r>
              <a:rPr lang="en-GB" sz="4000" dirty="0" smtClean="0">
                <a:latin typeface="Segoe UI Semibold" panose="020B0702040204020203" pitchFamily="34" charset="0"/>
                <a:cs typeface="Segoe UI Semibold" panose="020B0702040204020203" pitchFamily="34" charset="0"/>
              </a:rPr>
              <a:t>Fig. S2</a:t>
            </a:r>
            <a:endParaRPr lang="en-GB" sz="4000" dirty="0">
              <a:latin typeface="Segoe UI Semibold" panose="020B0702040204020203" pitchFamily="34" charset="0"/>
              <a:cs typeface="Segoe UI Semibold" panose="020B0702040204020203" pitchFamily="34" charset="0"/>
            </a:endParaRP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78316703"/>
              </p:ext>
            </p:extLst>
          </p:nvPr>
        </p:nvGraphicFramePr>
        <p:xfrm>
          <a:off x="1997293" y="0"/>
          <a:ext cx="8861090" cy="61500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r:id="rId4" imgW="4482720" imgH="3111840" progId="">
                  <p:embed/>
                </p:oleObj>
              </mc:Choice>
              <mc:Fallback>
                <p:oleObj r:id="rId4" imgW="4482720" imgH="3111840" progId="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997293" y="0"/>
                        <a:ext cx="8861090" cy="615004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Rectangle 2"/>
          <p:cNvSpPr/>
          <p:nvPr/>
        </p:nvSpPr>
        <p:spPr>
          <a:xfrm>
            <a:off x="1997293" y="5994890"/>
            <a:ext cx="9098972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i="1" dirty="0">
                <a:latin typeface="Gentium Basic" panose="02000503060000020004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Fig. S2.  The glyceride profile of cows’ milk (</a:t>
            </a:r>
            <a:r>
              <a:rPr lang="en-GB" sz="1400" i="1" dirty="0" err="1">
                <a:latin typeface="Gentium Basic" panose="02000503060000020004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Bov</a:t>
            </a:r>
            <a:r>
              <a:rPr lang="en-GB" sz="1400" i="1" dirty="0">
                <a:latin typeface="Gentium Basic" panose="02000503060000020004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-) and soya milk, collected in the positive mode of Direct Infusion MS.  </a:t>
            </a:r>
            <a:r>
              <a:rPr lang="en-GB" sz="1400" i="1" dirty="0" smtClean="0">
                <a:latin typeface="Gentium Basic" panose="02000503060000020004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Whole, unwashed; PW, washed </a:t>
            </a:r>
            <a:r>
              <a:rPr lang="en-GB" sz="1400" i="1" smtClean="0">
                <a:latin typeface="Gentium Basic" panose="02000503060000020004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with hexane.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30245972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44</Words>
  <Application>Microsoft Office PowerPoint</Application>
  <PresentationFormat>Widescreen</PresentationFormat>
  <Paragraphs>4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Gentium Basic</vt:lpstr>
      <vt:lpstr>Segoe UI Semibold</vt:lpstr>
      <vt:lpstr>Times New Roman</vt:lpstr>
      <vt:lpstr>Office Theme</vt:lpstr>
      <vt:lpstr>Fig. S2</vt:lpstr>
    </vt:vector>
  </TitlesOfParts>
  <Company>Clinical School Computing Servic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 1</dc:title>
  <dc:creator>Samuel Furse</dc:creator>
  <cp:lastModifiedBy>Samuel Furse</cp:lastModifiedBy>
  <cp:revision>8</cp:revision>
  <dcterms:created xsi:type="dcterms:W3CDTF">2019-04-10T14:00:46Z</dcterms:created>
  <dcterms:modified xsi:type="dcterms:W3CDTF">2019-04-29T07:44:47Z</dcterms:modified>
</cp:coreProperties>
</file>